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  <p:sldId id="256" r:id="rId3"/>
    <p:sldId id="257" r:id="rId4"/>
    <p:sldId id="258" r:id="rId5"/>
    <p:sldId id="259" r:id="rId6"/>
    <p:sldId id="261" r:id="rId7"/>
    <p:sldId id="260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0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"/>
          <p:cNvSpPr txBox="1"/>
          <p:nvPr/>
        </p:nvSpPr>
        <p:spPr>
          <a:xfrm>
            <a:off x="611560" y="1628800"/>
            <a:ext cx="8336772" cy="15513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890" dirty="0" err="1"/>
              <a:t>InterProScan</a:t>
            </a:r>
            <a:endParaRPr lang="en-US" altLang="zh-CN" sz="5890" dirty="0"/>
          </a:p>
          <a:p>
            <a:r>
              <a:rPr lang="en-US" altLang="zh-CN" sz="3600" dirty="0"/>
              <a:t>(http://www.ebi.ac.uk/Tools/pfa/iprscan5/)</a:t>
            </a:r>
            <a:endParaRPr lang="zh-CN" altLang="en-US" sz="3600" dirty="0"/>
          </a:p>
        </p:txBody>
      </p:sp>
    </p:spTree>
    <p:extLst>
      <p:ext uri="{BB962C8B-B14F-4D97-AF65-F5344CB8AC3E}">
        <p14:creationId xmlns:p14="http://schemas.microsoft.com/office/powerpoint/2010/main" val="35009316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116632"/>
            <a:ext cx="7075835" cy="6570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57866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648" y="548680"/>
            <a:ext cx="5463456" cy="51803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008101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404664"/>
            <a:ext cx="6319366" cy="61886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364376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188640"/>
            <a:ext cx="6001990" cy="6433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6815698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260648"/>
            <a:ext cx="6907436" cy="6295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4345793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116632"/>
            <a:ext cx="6937722" cy="63269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67229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753" y="188640"/>
            <a:ext cx="7285385" cy="65552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0624186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260648"/>
            <a:ext cx="6588348" cy="61562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8613849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4354"/>
            <a:ext cx="7283103" cy="63671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6623841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332656"/>
            <a:ext cx="6712744" cy="58426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764810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116632"/>
            <a:ext cx="7659911" cy="65143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613790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224259"/>
            <a:ext cx="6441964" cy="55453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2890805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371013" cy="7780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9288680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116632"/>
            <a:ext cx="7416824" cy="6426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0575078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188639"/>
            <a:ext cx="7128792" cy="63600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3908204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0"/>
            <a:ext cx="7721253" cy="63567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3333250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334"/>
            <a:ext cx="8028508" cy="67208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1507515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116632"/>
            <a:ext cx="7465219" cy="644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8174953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0"/>
            <a:ext cx="7858968" cy="67066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207118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332656"/>
            <a:ext cx="8054645" cy="6183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341123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488" y="23813"/>
            <a:ext cx="8961437" cy="6808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69950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608" y="404664"/>
            <a:ext cx="6693123" cy="56714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0125146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16632"/>
            <a:ext cx="7800145" cy="66255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8085806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404664"/>
            <a:ext cx="7042815" cy="5857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437513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620688"/>
            <a:ext cx="6968344" cy="61374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465121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433569"/>
            <a:ext cx="6895430" cy="60699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62175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6512" y="332656"/>
            <a:ext cx="8913019" cy="6726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62115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175" y="2114"/>
            <a:ext cx="8628063" cy="6570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348937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640" y="188640"/>
            <a:ext cx="6242855" cy="61188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903461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116632"/>
            <a:ext cx="6239545" cy="61894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0528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6</Words>
  <Application>Microsoft Office PowerPoint</Application>
  <PresentationFormat>全屏显示(4:3)</PresentationFormat>
  <Paragraphs>2</Paragraphs>
  <Slides>3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1</vt:i4>
      </vt:variant>
    </vt:vector>
  </HeadingPairs>
  <TitlesOfParts>
    <vt:vector size="32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User</cp:lastModifiedBy>
  <cp:revision>8</cp:revision>
  <dcterms:created xsi:type="dcterms:W3CDTF">2019-03-29T03:17:16Z</dcterms:created>
  <dcterms:modified xsi:type="dcterms:W3CDTF">2019-03-29T05:23:32Z</dcterms:modified>
</cp:coreProperties>
</file>